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6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18"/>
    <p:restoredTop sz="96327"/>
  </p:normalViewPr>
  <p:slideViewPr>
    <p:cSldViewPr snapToGrid="0">
      <p:cViewPr varScale="1">
        <p:scale>
          <a:sx n="254" d="100"/>
          <a:sy n="254" d="100"/>
        </p:scale>
        <p:origin x="232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21B50-4074-92DF-A35D-A0ACC53DB0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6CB506-65D5-B960-9C1C-DAD842EB72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2DDBB-EA5A-F28D-6216-FF2998FFE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B4CC5-E24E-C47D-6BA2-7259B7B3F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CC72FC-4826-7C1A-DC3E-CA789EA7F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8193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6769F7-7C8E-CD46-AEB5-FE86809B0A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7CF4CD-088B-0AFB-2DD0-84CF5B4243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2205ED-487D-5787-1441-2D84E179F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961E2C-38C6-1A2C-FA8E-15842CBE8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CB575D-F012-1846-3DA9-214D0681B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2092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ED8099-F083-A037-60DD-6C164160C9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0C1FAB-6D2F-7815-F7BB-7762BECCC6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D1BB62-5ABE-D94A-0C80-718774F7F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E3BF7-18C7-28E9-A9C2-17AE45C44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D00B3-D578-FBB3-00A2-0E69BC67F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25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70F9E-9FCC-0F16-2504-F322E16BFC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DA4730-637F-20F7-4FA8-B0A2F59380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589B9-AA5E-FEB6-F94D-F3E2BCDAF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6461CE-ACC2-FB13-15CF-1492C25BF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179467-A5BE-91EB-97B6-5A2EE8A10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9433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558194-7F99-AAD0-FA71-59B70DD5A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24D05-E9D7-5E49-0112-A4839243E6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771A25-49ED-7980-BEDA-860BA7ECC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9611FE-5909-C1D4-A38D-63E7E6800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1CA76E-6533-6412-32C0-0932ADB0B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8122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1BC94-C305-6829-DB4B-29D716E6C1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7591A-F3FB-379A-EAC2-87097E5FAB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4F18DA-F1B3-091E-293C-6230AE97F0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5893E0-9C48-B421-E454-2E1FAC26D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9D90FB-C0EC-5C64-68B5-3E3D18A5F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12633E-B570-6A8D-02BC-D3B7B6052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3512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657EB-7A00-9237-3211-8A6818CFA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4591C1-7FC4-9DC4-475F-2E99F38F2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D2FDDD-7041-4A5A-49A3-098B25651F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EAC099-1047-8B31-C88A-2B80DBD305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65132F-42A7-19F2-EE9F-5442557893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457F18-A40C-2CB5-7DCC-945E45431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8AB4AC-A7DE-CE44-E6D9-9A8EA6599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AD43A3-BE33-3450-0223-92CCADE20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558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DF9EB-78C3-2106-3EB5-1972CFD820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7BBBED-01EE-8BFC-CA7C-232BDA772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826469-83A8-01D9-CA51-D226105518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1394CB-6C30-22B7-5FEE-437A802DE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956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C463AE-F7B3-42DC-B110-B4B925A67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1EADE7-9201-224E-1D95-06522A073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A5284F-064E-E9C1-9690-24E7EC482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3646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06AD4-93ED-5210-B9B4-ECA32D4F73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A56B02-B4AD-086B-5BB4-AC2C97B2BC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4DF68F-A74C-F6BB-015B-D62B12251F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6355CF-27D4-5F59-B426-19A203C88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214DA4-BCB7-CFB7-EBAF-39B044A37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D128FC-40B4-2271-702E-2A334DE36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6119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BCF05-0512-33B0-EA7F-2279D9FEB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169107-8E7B-B09C-C302-4F46239B2C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F20234-C42B-F2C0-B609-CE1FB1B3BB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B8F2E6-6317-D18B-2B42-8FDEB6E2D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A1D47C-62C7-098A-D5C1-778B8F4C4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80D53F-7D00-56EA-68FE-97CC3543A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4484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846A99-E6F3-4D6B-C924-624199053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947C5-B15E-CD7B-4E17-DDA1E77293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32091-0BC3-86EC-D7E5-3D893FD4D8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26C04-4138-C146-BE50-A9AC5C97A7CC}" type="datetimeFigureOut">
              <a:rPr lang="en-US" smtClean="0"/>
              <a:t>11/30/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0D3530-9D3B-6F02-88B9-9A7A3A7C26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2727E-C232-4F47-CF09-620224358B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0AD7B-CB58-0740-A6A5-B55941DAE08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600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6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6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9B55A-81D6-AFF6-582B-CDA6A741E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Supplementary materials – network comparis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50A2E5-774C-E842-79EB-B068E96655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47329"/>
            <a:ext cx="10515600" cy="4470672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All resting state networks in a 25-component group independent component analysis of resting state data from 12 squirrel monkeys (6F;6M).</a:t>
            </a:r>
          </a:p>
          <a:p>
            <a:r>
              <a:rPr lang="en-US" dirty="0"/>
              <a:t>The top row shows the networks derived from the preprocessed resting state data prior to sLFO signal removal.</a:t>
            </a:r>
          </a:p>
          <a:p>
            <a:r>
              <a:rPr lang="en-US" dirty="0"/>
              <a:t>The middle row shows the networks derived from the data after sLFO removal using rapidtide.  Networks  were matched between analyses using </a:t>
            </a:r>
            <a:r>
              <a:rPr lang="en-US" dirty="0" err="1"/>
              <a:t>PICAchooser</a:t>
            </a:r>
            <a:r>
              <a:rPr lang="en-US" dirty="0"/>
              <a:t> (Frederick, 2020).</a:t>
            </a:r>
          </a:p>
          <a:p>
            <a:r>
              <a:rPr lang="en-US" dirty="0"/>
              <a:t>The bottom row shows voxels with a significant decrease in z value after rapidtide correction (p&lt;0.05, after with threshold-free cluster enhancement).</a:t>
            </a:r>
          </a:p>
          <a:p>
            <a:r>
              <a:rPr lang="en-US" dirty="0"/>
              <a:t>Network assignments are done in part with reference to Belcher, 2013 and Gao et al, 2013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82299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66CD503-C059-9328-5F43-F5F6456136CC}"/>
              </a:ext>
            </a:extLst>
          </p:cNvPr>
          <p:cNvSpPr txBox="1"/>
          <p:nvPr/>
        </p:nvSpPr>
        <p:spPr>
          <a:xfrm>
            <a:off x="566057" y="5826034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2B67B73-3CBC-8E4D-9B2F-AFDC8D6FA7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3571" y="355918"/>
            <a:ext cx="5560283" cy="54701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228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F8F4F6AA-51D7-FD3D-8E02-8CC4FDF694F1}"/>
              </a:ext>
            </a:extLst>
          </p:cNvPr>
          <p:cNvSpPr/>
          <p:nvPr/>
        </p:nvSpPr>
        <p:spPr>
          <a:xfrm>
            <a:off x="485426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0F70B67-3CF3-482B-AC11-FD1FA3549D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748717"/>
            <a:ext cx="2626297" cy="289137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E024A3B-2E4A-C5FC-8371-19ACC84EEF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5048" y="748717"/>
            <a:ext cx="2626297" cy="289137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9E194D8-443C-DBA7-DA43-42D5A49960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74608" y="748717"/>
            <a:ext cx="2626297" cy="289137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313A9B3-6B44-62BC-0F96-799039C245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74169" y="748717"/>
            <a:ext cx="2626297" cy="2891374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D2FE6C9F-AC68-33C6-4AF9-666DAA7674CE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D290EC0-B4D2-5A6C-B383-CD12BCF63172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CDA3A7F-582D-8367-BC53-8D5EFC16BB0C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47313E7-2209-298B-7D74-B5C31691CBB4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0B10BD0-99E0-8B4C-D830-BCD944130A8B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3849C4E-8338-F589-7116-46CCC9AF56BF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C662647-03AF-C731-2224-833989C1A665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04FAB4D-AAFC-41B6-F297-A5080D60DE98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2FD2F9-4D5C-7DC9-9B65-2AEE6606CB13}"/>
              </a:ext>
            </a:extLst>
          </p:cNvPr>
          <p:cNvSpPr txBox="1"/>
          <p:nvPr/>
        </p:nvSpPr>
        <p:spPr>
          <a:xfrm>
            <a:off x="3166307" y="3648630"/>
            <a:ext cx="26517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: Cingulate, somatosensory area, ventral parieta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0DCF67-1DA0-0BB6-6FA9-195EF26609EB}"/>
              </a:ext>
            </a:extLst>
          </p:cNvPr>
          <p:cNvSpPr txBox="1"/>
          <p:nvPr/>
        </p:nvSpPr>
        <p:spPr>
          <a:xfrm>
            <a:off x="5920376" y="3648630"/>
            <a:ext cx="2651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3: Midbrain, reticulum, pon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F9AAAD-B4C4-C53B-75D1-03BAA7F19F84}"/>
              </a:ext>
            </a:extLst>
          </p:cNvPr>
          <p:cNvSpPr txBox="1"/>
          <p:nvPr/>
        </p:nvSpPr>
        <p:spPr>
          <a:xfrm>
            <a:off x="8674444" y="3648630"/>
            <a:ext cx="26517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4: Temporal cortex (fissure), posterior pariet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40975A-1E48-F8B5-4F9F-1F8522C34283}"/>
              </a:ext>
            </a:extLst>
          </p:cNvPr>
          <p:cNvSpPr txBox="1"/>
          <p:nvPr/>
        </p:nvSpPr>
        <p:spPr>
          <a:xfrm>
            <a:off x="412238" y="3648630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: Lateral visual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7689291-3409-2A84-D4C0-FF92506EA2B2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67B0A65-8DA3-62AA-652A-29FA5F6A1B10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F387725-4473-17F4-167B-87FF6051F981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386808B-61F4-0319-F0E0-845EA7C5CC42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3F2D7D6-441A-63E6-D500-AA6B1BFCA9DB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0C3B473-24FC-7E2B-1041-DA03607630A0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CBC36578-062F-CD63-950A-8A3D3575F0E5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8DF6372-4AC1-DA1F-B580-12BB3B52CD72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0688E38-77EE-3F3D-8985-236BBF0443D1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4F661F5-2270-C427-233F-2A0D83529E04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F681DE1-0A26-A10E-CF4A-5E06E3A02470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0E39C5C-0452-C024-6C5F-FEB20BB5A3B5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4EDA94D-2A6C-D40F-1473-35A91B61EC2D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FA61996-C9B3-B959-1CCC-4673E5DA428A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2F1471E-9B8D-C5E0-4BAE-D56D4ABB011C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EABE065-3709-3DFE-8F1F-4D1E811D0EA9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1961176-E5C1-0DD3-FD03-2AEBBEF22DBA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50678B50-705C-9C9C-F82A-093CD569F762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0B5B381-2655-F417-1C92-4780001411D7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495D6DB-0860-7493-CE8A-5F1ACE8B1A54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D63BDD6-695B-274A-D0F6-82D691CA42FF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31AEC7F-78DA-59D6-2D98-F5F6224F91E0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A</a:t>
            </a:r>
          </a:p>
        </p:txBody>
      </p:sp>
    </p:spTree>
    <p:extLst>
      <p:ext uri="{BB962C8B-B14F-4D97-AF65-F5344CB8AC3E}">
        <p14:creationId xmlns:p14="http://schemas.microsoft.com/office/powerpoint/2010/main" val="4237809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E8062EB7-297F-46F8-A953-DE33B7590981}"/>
              </a:ext>
            </a:extLst>
          </p:cNvPr>
          <p:cNvSpPr/>
          <p:nvPr/>
        </p:nvSpPr>
        <p:spPr>
          <a:xfrm>
            <a:off x="475487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693F9E3-041E-66FB-4CB0-15F132D2E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753802"/>
            <a:ext cx="2624328" cy="28892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02598B4-BCEE-2A22-E068-5D18EC5FB3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7016" y="753802"/>
            <a:ext cx="2624328" cy="288920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63C3292-A7EE-AF8F-C0C4-BC52736904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9011" y="749808"/>
            <a:ext cx="2627956" cy="28932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CB7EF12-B57F-E145-1A45-F8ED384810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74169" y="749808"/>
            <a:ext cx="2627956" cy="289320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53442F93-7A71-5459-A4D8-1DF22C8340CA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FA8AC05-3B2C-6A06-3723-D609BC45CA23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FC59067-464E-D1ED-5714-3DB430F66E41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6477F3F-5CEE-4E05-A803-DF8D7EA090CF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3692D5B-A48E-A466-4987-8A4F464A2F91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FFB027E-B7EB-C454-B1CC-CD11431879DB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A0F6B83-E6FE-B7D5-1C29-4E9E9C0402FF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9E27D83-7C6D-0473-FDFF-6511A380BD40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0ACE55-8E12-8BE0-D577-5332F9C2FCD3}"/>
              </a:ext>
            </a:extLst>
          </p:cNvPr>
          <p:cNvSpPr txBox="1"/>
          <p:nvPr/>
        </p:nvSpPr>
        <p:spPr>
          <a:xfrm>
            <a:off x="660549" y="3643008"/>
            <a:ext cx="213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5: Amygdala, nucleus </a:t>
            </a:r>
            <a:r>
              <a:rPr lang="en-US" err="1"/>
              <a:t>accumbens</a:t>
            </a:r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B44AAC-9651-76D6-7C15-DC429AA3AE10}"/>
              </a:ext>
            </a:extLst>
          </p:cNvPr>
          <p:cNvSpPr txBox="1"/>
          <p:nvPr/>
        </p:nvSpPr>
        <p:spPr>
          <a:xfrm>
            <a:off x="8847777" y="3643008"/>
            <a:ext cx="2247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8:  Occipital corte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75C2A8-7C65-CC44-7607-F780C9947F45}"/>
              </a:ext>
            </a:extLst>
          </p:cNvPr>
          <p:cNvSpPr txBox="1"/>
          <p:nvPr/>
        </p:nvSpPr>
        <p:spPr>
          <a:xfrm>
            <a:off x="6073545" y="3643008"/>
            <a:ext cx="22013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7: Left occipital cortex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7A46ACD-6271-BC32-EE01-97CD230E5922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62D660A-5A4E-7FC1-AFD3-BAD1C0D425B3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2FC7368-D01B-A468-3A48-7277299D3D52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9DCBFFD-9711-AA90-6C8A-92FA8385CA12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4ED7FAE-D695-BCFD-CA08-DB6F0DA2EB4C}"/>
              </a:ext>
            </a:extLst>
          </p:cNvPr>
          <p:cNvCxnSpPr>
            <a:cxnSpLocks/>
          </p:cNvCxnSpPr>
          <p:nvPr/>
        </p:nvCxnSpPr>
        <p:spPr>
          <a:xfrm>
            <a:off x="6069011" y="740178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0EDF26D2-10F6-53C2-C900-0F36EBE1F9B5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4F788901-FA75-68B0-7347-DA4AE1E1CC91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116D3B5-C3FE-7F1F-7F50-F688565B09EC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2AF8B68-C7F3-D7F5-E6FE-6B272DB9E2D2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E2B7261-8ABB-8784-CDA3-03B9A684FD2F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E768777-7BD0-5037-AF35-8E15C83FCA08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9046569-37AB-D049-6180-77CF97998501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52C09F5-F15F-9C52-C335-A06A35020CC6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9AB4A40-C184-8AFD-EB28-0D751FDF936D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990B7E8-9946-B080-F45A-46C34B2A7C80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53FCFF3-2E9F-13F6-992D-D543BC872243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11EA275-92DF-52A5-EDF4-5E13B9BDA411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3E8B168-6433-E862-030B-C771464BFF36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B735BE6B-7B4F-457B-B248-4138C85E0A36}"/>
              </a:ext>
            </a:extLst>
          </p:cNvPr>
          <p:cNvSpPr txBox="1"/>
          <p:nvPr/>
        </p:nvSpPr>
        <p:spPr>
          <a:xfrm>
            <a:off x="3367047" y="3643008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6: Draining vessels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736F9163-F5D7-0ABB-203C-A8DF1DB088AC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223FAED-EB51-8C8A-C87C-DAC760F9C6F5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30B45D5-22D5-746A-3B00-E4F882DF20AE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3092F0D-873B-D35D-BC30-DB5FB73EC061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7EC68716-CCC3-EFED-08D4-24B99DC27590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B</a:t>
            </a:r>
          </a:p>
        </p:txBody>
      </p:sp>
    </p:spTree>
    <p:extLst>
      <p:ext uri="{BB962C8B-B14F-4D97-AF65-F5344CB8AC3E}">
        <p14:creationId xmlns:p14="http://schemas.microsoft.com/office/powerpoint/2010/main" val="1395014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264F4178-3E84-76C6-D0AD-35BD29D67EE4}"/>
              </a:ext>
            </a:extLst>
          </p:cNvPr>
          <p:cNvSpPr/>
          <p:nvPr/>
        </p:nvSpPr>
        <p:spPr>
          <a:xfrm>
            <a:off x="475487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8EF9AB2-BF4D-F969-E329-5DF2013B6E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749808"/>
            <a:ext cx="2624328" cy="28892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544AD96-CF73-81CD-2522-92895E5E1A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7016" y="749808"/>
            <a:ext cx="2624328" cy="28892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AAE0CED-9667-9D04-F318-6F4DA31FA3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7166" y="749808"/>
            <a:ext cx="2624328" cy="288920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46CBF4F-2F2F-E872-FB8B-F410B42DCD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9680" y="749808"/>
            <a:ext cx="2624328" cy="288920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A07A5A5B-D744-5633-C185-3D113E4A72BA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21406FA-5E14-B0AB-B465-898B081520F2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2404FD6-8228-BCC7-9D84-87810EB03B41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F1B8C85-40B9-9381-90DD-8E26FB030E3F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EC397CC-D95D-9D0C-CC2A-2F3F4BF4CBEA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106ADB4-E04A-E88F-FE48-82E2113F69BE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2B2E31E-164E-F8D8-E91D-DCDB4781AAF5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F866E7F-A00F-ABC7-45FE-019EAE1ADC79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515EE3-990B-D66C-EB86-F88B0DC07D6C}"/>
              </a:ext>
            </a:extLst>
          </p:cNvPr>
          <p:cNvSpPr txBox="1"/>
          <p:nvPr/>
        </p:nvSpPr>
        <p:spPr>
          <a:xfrm>
            <a:off x="686985" y="3635596"/>
            <a:ext cx="22013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9: Right occipital cortex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6A3898-1032-CD0A-6D69-2C4E12D26BAA}"/>
              </a:ext>
            </a:extLst>
          </p:cNvPr>
          <p:cNvSpPr txBox="1"/>
          <p:nvPr/>
        </p:nvSpPr>
        <p:spPr>
          <a:xfrm>
            <a:off x="6187112" y="3635596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1: OFC, </a:t>
            </a:r>
            <a:r>
              <a:rPr lang="en-US" err="1"/>
              <a:t>mOFC</a:t>
            </a:r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EE5107C-7699-9C82-2769-6DD61DD45C66}"/>
              </a:ext>
            </a:extLst>
          </p:cNvPr>
          <p:cNvSpPr txBox="1"/>
          <p:nvPr/>
        </p:nvSpPr>
        <p:spPr>
          <a:xfrm>
            <a:off x="8846159" y="3635596"/>
            <a:ext cx="26478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2: ACC, frontal cortex, DLPFC, </a:t>
            </a:r>
            <a:r>
              <a:rPr lang="en-US" err="1"/>
              <a:t>mPFC</a:t>
            </a:r>
            <a:r>
              <a:rPr lang="en-US"/>
              <a:t>, putame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3F34FD-E885-F17D-6297-4AD81D6686DF}"/>
              </a:ext>
            </a:extLst>
          </p:cNvPr>
          <p:cNvSpPr txBox="1"/>
          <p:nvPr/>
        </p:nvSpPr>
        <p:spPr>
          <a:xfrm>
            <a:off x="3413765" y="3635596"/>
            <a:ext cx="22479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0: </a:t>
            </a:r>
            <a:r>
              <a:rPr lang="en-US" err="1"/>
              <a:t>mOFC</a:t>
            </a:r>
            <a:r>
              <a:rPr lang="en-US"/>
              <a:t>, </a:t>
            </a:r>
            <a:r>
              <a:rPr lang="en-US" err="1"/>
              <a:t>temoral</a:t>
            </a:r>
            <a:r>
              <a:rPr lang="en-US"/>
              <a:t> pole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DA955B0-7078-D8EC-3458-1564F1EE5560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D2799EC-2FCF-DD8A-9584-9C6A2EF0451B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C4301A6-8A0A-3E38-DA41-14F8F53B29FC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4889D5A-AADA-E4F4-39DE-5F446005A61C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D61A679C-6A0B-C5F9-6327-C92A218FE7CB}"/>
              </a:ext>
            </a:extLst>
          </p:cNvPr>
          <p:cNvCxnSpPr>
            <a:cxnSpLocks/>
          </p:cNvCxnSpPr>
          <p:nvPr/>
        </p:nvCxnSpPr>
        <p:spPr>
          <a:xfrm>
            <a:off x="8881856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BB15C84-88A1-9032-1B80-1261F70AA5FA}"/>
              </a:ext>
            </a:extLst>
          </p:cNvPr>
          <p:cNvCxnSpPr>
            <a:cxnSpLocks/>
          </p:cNvCxnSpPr>
          <p:nvPr/>
        </p:nvCxnSpPr>
        <p:spPr>
          <a:xfrm>
            <a:off x="6056813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>
            <a:extLst>
              <a:ext uri="{FF2B5EF4-FFF2-40B4-BE49-F238E27FC236}">
                <a16:creationId xmlns:a16="http://schemas.microsoft.com/office/drawing/2014/main" id="{AA8D1B34-755C-8612-CAEF-A9D47A702DED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33ACFE2-3182-8EF8-3541-B1D2975D3E62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C385156D-EF6A-BF59-BE75-857EA3E4600B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9A3D2E3B-975D-ED32-5603-8BCD40E7C7E3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9620687-3201-E00E-BC9B-762CDA03707D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627DA10-6D67-CB7D-FA15-BC1DA0046ACB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58EB7F3-2AA8-31C9-C7CB-6F1B7E8FD5A9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0447E65-3C87-ECD7-2053-D7B283452851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D471FC9-61E8-2F1A-0DF2-76373F468324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83AA499-2AC0-EA19-8D5B-0180D3C7C6FB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53A098E-4D5F-C3C1-D591-AFEE0E94D246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315D37C-D2F3-5786-8721-E470CC1C9A83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C7CFC8E-FE61-4E8C-D317-B64934038F31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0F284B37-94B6-BC12-366A-5EBC0C35FCE3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A83CA7A-AF4E-F0B9-D5FA-E2CD0A493CD7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E09E72B-CDD4-B1B9-1E7F-05515370FDFB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C302817-C84F-BC40-8F86-848CE272C33A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C4FFE048-0651-1FDA-8C08-25F586E000EE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C</a:t>
            </a:r>
          </a:p>
        </p:txBody>
      </p:sp>
    </p:spTree>
    <p:extLst>
      <p:ext uri="{BB962C8B-B14F-4D97-AF65-F5344CB8AC3E}">
        <p14:creationId xmlns:p14="http://schemas.microsoft.com/office/powerpoint/2010/main" val="6727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A715888D-8E76-57D2-EBE9-0CFFCA8D74CD}"/>
              </a:ext>
            </a:extLst>
          </p:cNvPr>
          <p:cNvSpPr/>
          <p:nvPr/>
        </p:nvSpPr>
        <p:spPr>
          <a:xfrm>
            <a:off x="475487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30BE91D-381D-E117-2C7C-A2E66DBCA2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749808"/>
            <a:ext cx="2624328" cy="28892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39D8DCC-CB42-8DA6-3F54-5E0DEEB439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1543" y="749808"/>
            <a:ext cx="2624328" cy="28892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24C6710-D4DE-692C-04B0-C40B8186A2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70885" y="749808"/>
            <a:ext cx="2624328" cy="288920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94DB721-A1B5-7A5C-5DD6-E94E28366F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9680" y="749808"/>
            <a:ext cx="2624328" cy="288920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35F3C564-DC7C-8E28-02B2-4657933861F4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0D0F7A5-0DB1-F3A5-2AC5-773D1E1715CA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B891EA8-75E9-D438-0908-C4E7F97F0D68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BBE8BDC-FB45-704B-794C-71BCA25EC5CE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2BFC2CB-596A-36E1-1951-505B668EB396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5F09765-FFDF-77D6-B609-82E890B46887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861A23A-A846-89D9-CB92-DA8C8EAE6848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9E84447-F1D2-DBB0-EDA9-D0E2A5C83666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7619C43-51B1-BABC-916D-364BD9DBB38F}"/>
              </a:ext>
            </a:extLst>
          </p:cNvPr>
          <p:cNvSpPr txBox="1"/>
          <p:nvPr/>
        </p:nvSpPr>
        <p:spPr>
          <a:xfrm>
            <a:off x="3305485" y="3614734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4: Cerebellu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FFD4460-41EC-9E0F-CFE3-022AE10807FE}"/>
              </a:ext>
            </a:extLst>
          </p:cNvPr>
          <p:cNvSpPr txBox="1"/>
          <p:nvPr/>
        </p:nvSpPr>
        <p:spPr>
          <a:xfrm>
            <a:off x="8669765" y="3614734"/>
            <a:ext cx="28236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6: Hippocampus, thalamus, posterior insular cortex, temporal pole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CB447DC-F2DA-6FB6-C868-AD574E3DA094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5BED3234-8D2F-AB1D-2A0A-25A79F814A18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517C57C-2BD2-AACE-765B-BAC493DF6DB5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36101FA-72AA-0831-001D-B100392536EB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61974CC-1AEE-7763-C647-B5A5A8BBE5D9}"/>
              </a:ext>
            </a:extLst>
          </p:cNvPr>
          <p:cNvCxnSpPr>
            <a:cxnSpLocks/>
          </p:cNvCxnSpPr>
          <p:nvPr/>
        </p:nvCxnSpPr>
        <p:spPr>
          <a:xfrm>
            <a:off x="8881856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oup 3">
            <a:extLst>
              <a:ext uri="{FF2B5EF4-FFF2-40B4-BE49-F238E27FC236}">
                <a16:creationId xmlns:a16="http://schemas.microsoft.com/office/drawing/2014/main" id="{C2D005FB-1E63-4AF0-A612-1F845DF95F60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59604E8-28C6-CDBA-35EB-9BE409894B02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720BA385-6A41-045D-4B85-F505A2565A77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FEE49307-D70C-CF58-8458-C21B8228E785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9E7445-7AC0-C25B-9E94-81965A326EEA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5A6D36B-8C16-6F05-A4E1-D74DE5C5667C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C9F89A8-87D8-3164-2F4B-5648FC978813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6153142-4501-3806-9DED-C2EE22536F78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4F5A7FB-0DE0-BC10-5C65-305885A97795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970B62B-C56F-FB1F-6259-63C6960C2436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B952F5E-4D75-EFAF-AD4F-C7471553B4F6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CA4D1D8-31DB-34EE-118D-56D6DA58D7C6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1D2C256-E3F9-2597-9A07-21EF6D987ED6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F10D3A22-A74F-349F-88F5-8DEEFE94A5D5}"/>
              </a:ext>
            </a:extLst>
          </p:cNvPr>
          <p:cNvSpPr txBox="1"/>
          <p:nvPr/>
        </p:nvSpPr>
        <p:spPr>
          <a:xfrm>
            <a:off x="5949464" y="3614734"/>
            <a:ext cx="2508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5: Draining vessel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B664E7A-66D9-D595-B8ED-8B948CB8B9B5}"/>
              </a:ext>
            </a:extLst>
          </p:cNvPr>
          <p:cNvSpPr txBox="1"/>
          <p:nvPr/>
        </p:nvSpPr>
        <p:spPr>
          <a:xfrm>
            <a:off x="435893" y="3614734"/>
            <a:ext cx="2508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3: Artifact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9E5DE204-CE77-8084-97B9-DF4AE7D650F3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5849D86-F45A-8FDD-0DE9-C1E5A6944D18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2D2BF33-4D8A-0ABB-883A-AB452DD430F5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183811A-C3F6-FB04-B5B0-7D1928D1AB1C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8106BC50-A678-7546-5FA9-89539D0C8860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D</a:t>
            </a:r>
          </a:p>
        </p:txBody>
      </p:sp>
    </p:spTree>
    <p:extLst>
      <p:ext uri="{BB962C8B-B14F-4D97-AF65-F5344CB8AC3E}">
        <p14:creationId xmlns:p14="http://schemas.microsoft.com/office/powerpoint/2010/main" val="37897839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C36ED243-4AB8-9F99-5CB6-6B9347D9B07B}"/>
              </a:ext>
            </a:extLst>
          </p:cNvPr>
          <p:cNvSpPr/>
          <p:nvPr/>
        </p:nvSpPr>
        <p:spPr>
          <a:xfrm>
            <a:off x="475487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FDD05E-7DAF-7F7C-AD85-530F925803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88" y="749808"/>
            <a:ext cx="2624328" cy="28892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917F0E0-C316-908B-8221-7E9890F35D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1545" y="749808"/>
            <a:ext cx="2624328" cy="28892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F849706-6F24-DE3D-19F8-2FC00D77FB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5755" y="749808"/>
            <a:ext cx="2624328" cy="288920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3A5E948-6AF8-AB5E-EDF5-5D6AFABCBF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9680" y="749808"/>
            <a:ext cx="2624328" cy="288920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FDEC8F51-A6EA-A79F-1116-320ABF0E06B2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D158C47-2A17-CFB9-003A-388F5AC7463B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05600F0-7414-D667-CC21-781DA1046A4C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95CFCD-9F42-E4BC-571E-1A5FEC38D230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771EF96-4FC7-12E8-DF1E-6EF8F752D046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A7ADD83-F0D8-80E6-5E89-F6F39E0BECFB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C4D0BF7-B2E5-B6C2-BCB2-5F93457B3792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45CE717-6C53-8FD3-08F7-57D8AA62043A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FD56102-412C-6A89-35DB-FE9AB45C8F62}"/>
              </a:ext>
            </a:extLst>
          </p:cNvPr>
          <p:cNvSpPr txBox="1"/>
          <p:nvPr/>
        </p:nvSpPr>
        <p:spPr>
          <a:xfrm>
            <a:off x="329177" y="3648630"/>
            <a:ext cx="2898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7: Insula, inferior frontal gyrus, dorsolateral prefrontal cortex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978ABB-2426-70B3-26ED-AC7E13114BC8}"/>
              </a:ext>
            </a:extLst>
          </p:cNvPr>
          <p:cNvSpPr txBox="1"/>
          <p:nvPr/>
        </p:nvSpPr>
        <p:spPr>
          <a:xfrm>
            <a:off x="6052513" y="3657261"/>
            <a:ext cx="24595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9: Prefrontal cortex, medial orbitofrontal cortex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B8DBAB59-CD78-FFB4-C0D0-8D686AF09728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A732CF9-4351-56B6-96D5-F3050886064B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835377B-3CB3-EAA0-9771-950A556E9DF2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993247C-2E93-A2A4-6010-BB8A2379EC9D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2CB929F-39D6-D0B0-5C0C-5C056A2DCED6}"/>
              </a:ext>
            </a:extLst>
          </p:cNvPr>
          <p:cNvCxnSpPr>
            <a:cxnSpLocks/>
          </p:cNvCxnSpPr>
          <p:nvPr/>
        </p:nvCxnSpPr>
        <p:spPr>
          <a:xfrm>
            <a:off x="8881856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BE8552D-D28E-8FA6-237F-E83942C55A8A}"/>
              </a:ext>
            </a:extLst>
          </p:cNvPr>
          <p:cNvCxnSpPr>
            <a:cxnSpLocks/>
          </p:cNvCxnSpPr>
          <p:nvPr/>
        </p:nvCxnSpPr>
        <p:spPr>
          <a:xfrm>
            <a:off x="6065755" y="749040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224930E0-5D15-FF85-7E1A-FADC557B596C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DA36D374-0272-B905-7539-075C1E1472E6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C761B2F-8213-CCD5-0F11-F5E6C7E2399D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DFA36556-03A1-3464-96C7-8CC1D02968C4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E211204-3F9E-3795-D08A-A63D475CD631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E6C2AB7-C103-441E-CD10-19ADB4ECDC30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FD4E248-80BA-F436-A08C-99A74E1F5C43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62D914C-76F9-B1B1-C18D-F8AB99C10375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8F8D275-8B1E-4493-C057-38A23C7254B3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A9293C3-5E02-F704-F39B-17FC8EEDAAEA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C0FA8D7-588C-F407-2070-526F7E4D1C04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6F54246-D294-BAF0-F9B6-C31A550C3007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3662FD0-0F2D-8179-10E7-398A7F66FB7B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D0324158-60BF-6D07-DF5E-B2A7365D5F17}"/>
              </a:ext>
            </a:extLst>
          </p:cNvPr>
          <p:cNvSpPr txBox="1"/>
          <p:nvPr/>
        </p:nvSpPr>
        <p:spPr>
          <a:xfrm>
            <a:off x="8863916" y="3641965"/>
            <a:ext cx="2508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0: Draining vessel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2DF6E8-3CC6-1830-D0DB-085274197843}"/>
              </a:ext>
            </a:extLst>
          </p:cNvPr>
          <p:cNvSpPr txBox="1"/>
          <p:nvPr/>
        </p:nvSpPr>
        <p:spPr>
          <a:xfrm>
            <a:off x="3186349" y="3657261"/>
            <a:ext cx="2508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18: Draining vessels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6F2F1587-0975-114C-DCBF-D0EBFC7528A8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B6A8B38-F7C2-48E0-612C-5EFCB1FAD41A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230D11B-0815-EC31-4778-45760326F6CE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4671B7E-5C58-F0FF-FC53-BE1E68732D3C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CC9A806C-5CCA-599C-E9C6-184168758669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E</a:t>
            </a:r>
          </a:p>
        </p:txBody>
      </p:sp>
    </p:spTree>
    <p:extLst>
      <p:ext uri="{BB962C8B-B14F-4D97-AF65-F5344CB8AC3E}">
        <p14:creationId xmlns:p14="http://schemas.microsoft.com/office/powerpoint/2010/main" val="33868152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7C90F1E-1DFA-CBB4-09D0-B40D12EBF092}"/>
              </a:ext>
            </a:extLst>
          </p:cNvPr>
          <p:cNvSpPr/>
          <p:nvPr/>
        </p:nvSpPr>
        <p:spPr>
          <a:xfrm>
            <a:off x="475487" y="748717"/>
            <a:ext cx="1137195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0A8A75-55DA-7935-0C4E-5BA22BE59BC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475488" y="749808"/>
            <a:ext cx="2624328" cy="288920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AAE1796-02FF-034B-A679-014BE25287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1979" y="749808"/>
            <a:ext cx="2624328" cy="288920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90FB3A6-B5BC-99E0-A3C1-A3FF5A43866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81"/>
          <a:stretch/>
        </p:blipFill>
        <p:spPr>
          <a:xfrm>
            <a:off x="6162330" y="749808"/>
            <a:ext cx="2527734" cy="288920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B39FA8A-0611-6A63-E097-784E14BFCE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9680" y="749808"/>
            <a:ext cx="2624328" cy="2889206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1A85DCA6-80C1-2E10-3931-2E63C266B721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F3CAF52-37FE-F012-95C9-BA204231510A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4FFF85F-EE11-90D3-FF2E-4AEF0CBEF796}"/>
              </a:ext>
            </a:extLst>
          </p:cNvPr>
          <p:cNvSpPr/>
          <p:nvPr/>
        </p:nvSpPr>
        <p:spPr>
          <a:xfrm>
            <a:off x="327701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AFAEA86-9CD9-5E15-5CE0-8489AE887888}"/>
              </a:ext>
            </a:extLst>
          </p:cNvPr>
          <p:cNvSpPr/>
          <p:nvPr/>
        </p:nvSpPr>
        <p:spPr>
          <a:xfrm>
            <a:off x="3277016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DD15654-2B93-92F1-426F-AF2429C3E815}"/>
              </a:ext>
            </a:extLst>
          </p:cNvPr>
          <p:cNvSpPr/>
          <p:nvPr/>
        </p:nvSpPr>
        <p:spPr>
          <a:xfrm>
            <a:off x="607362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260ABF7-803A-75D5-E4EC-B35C8DE4B87C}"/>
              </a:ext>
            </a:extLst>
          </p:cNvPr>
          <p:cNvSpPr/>
          <p:nvPr/>
        </p:nvSpPr>
        <p:spPr>
          <a:xfrm>
            <a:off x="8875153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688BB9A-9AD3-CB3E-519F-59923DC0EE82}"/>
              </a:ext>
            </a:extLst>
          </p:cNvPr>
          <p:cNvSpPr/>
          <p:nvPr/>
        </p:nvSpPr>
        <p:spPr>
          <a:xfrm>
            <a:off x="887416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933B7CF-B019-4CF8-3F96-D7DFA8655CD2}"/>
              </a:ext>
            </a:extLst>
          </p:cNvPr>
          <p:cNvSpPr/>
          <p:nvPr/>
        </p:nvSpPr>
        <p:spPr>
          <a:xfrm>
            <a:off x="6072639" y="2609052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01AEF2F-8C8B-AEE4-E126-09757F6A27AD}"/>
              </a:ext>
            </a:extLst>
          </p:cNvPr>
          <p:cNvSpPr txBox="1"/>
          <p:nvPr/>
        </p:nvSpPr>
        <p:spPr>
          <a:xfrm>
            <a:off x="475485" y="3675661"/>
            <a:ext cx="2651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1: Right entorhinal cortex, amygdal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C8B71C2-2955-0434-E1D4-6048E4F5B390}"/>
              </a:ext>
            </a:extLst>
          </p:cNvPr>
          <p:cNvSpPr txBox="1"/>
          <p:nvPr/>
        </p:nvSpPr>
        <p:spPr>
          <a:xfrm>
            <a:off x="5968250" y="3671899"/>
            <a:ext cx="2651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3: Left entorhinal cortex, amygdala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EBFE5584-05F9-8218-F0E4-6C9C4FA30DBC}"/>
              </a:ext>
            </a:extLst>
          </p:cNvPr>
          <p:cNvCxnSpPr>
            <a:cxnSpLocks/>
          </p:cNvCxnSpPr>
          <p:nvPr/>
        </p:nvCxnSpPr>
        <p:spPr>
          <a:xfrm>
            <a:off x="3101784" y="655983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0588F6C-2114-D7D5-4113-3E979A8BF065}"/>
              </a:ext>
            </a:extLst>
          </p:cNvPr>
          <p:cNvCxnSpPr>
            <a:cxnSpLocks/>
          </p:cNvCxnSpPr>
          <p:nvPr/>
        </p:nvCxnSpPr>
        <p:spPr>
          <a:xfrm>
            <a:off x="8696967" y="502294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AD1428E-4DE9-2F5D-8439-B9CF14BED174}"/>
              </a:ext>
            </a:extLst>
          </p:cNvPr>
          <p:cNvCxnSpPr>
            <a:cxnSpLocks/>
          </p:cNvCxnSpPr>
          <p:nvPr/>
        </p:nvCxnSpPr>
        <p:spPr>
          <a:xfrm>
            <a:off x="5898806" y="501508"/>
            <a:ext cx="0" cy="3202546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39031CA-36A4-1BD9-AE25-DD5AAAB07B9E}"/>
              </a:ext>
            </a:extLst>
          </p:cNvPr>
          <p:cNvCxnSpPr>
            <a:cxnSpLocks/>
          </p:cNvCxnSpPr>
          <p:nvPr/>
        </p:nvCxnSpPr>
        <p:spPr>
          <a:xfrm>
            <a:off x="11498497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E2C2547-F230-958C-C257-41D65DC30C7E}"/>
              </a:ext>
            </a:extLst>
          </p:cNvPr>
          <p:cNvCxnSpPr>
            <a:cxnSpLocks/>
          </p:cNvCxnSpPr>
          <p:nvPr/>
        </p:nvCxnSpPr>
        <p:spPr>
          <a:xfrm>
            <a:off x="8869680" y="748717"/>
            <a:ext cx="0" cy="289991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0E269CC-A6D9-C9F8-F26F-57456DEFC0EB}"/>
              </a:ext>
            </a:extLst>
          </p:cNvPr>
          <p:cNvGrpSpPr/>
          <p:nvPr/>
        </p:nvGrpSpPr>
        <p:grpSpPr>
          <a:xfrm>
            <a:off x="11453309" y="693755"/>
            <a:ext cx="437113" cy="2980969"/>
            <a:chOff x="11453309" y="693755"/>
            <a:chExt cx="437113" cy="2980969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830CDDC0-87A7-7510-5DEF-F0A43533DAB9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4087D71D-D618-79FC-B236-1B9B2FA9231E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F621EB09-5586-868E-4444-E37245CC8253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EE0AC0D-63FE-F1DA-646C-D499F86F2A90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50BB616-C309-CC52-2DF1-9E90B5B2E217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C890867-AE98-7D31-6896-0C83B6DDF294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4F9FE0A-CD94-F996-0221-FE0966B5B40E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43ECDF3-47BB-1401-15FE-3F71C78E0965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E827774-D15B-8F59-CC8F-F47B35E31024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DBB9798-38EB-6433-5AD0-12D91C922046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F6C0A0E-6AA9-5A82-9195-F8907F64666B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B755043-D72B-26B3-F384-D8A0B17992A3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F86A34A5-9BB2-8075-75C4-3B9FF0E0474F}"/>
              </a:ext>
            </a:extLst>
          </p:cNvPr>
          <p:cNvSpPr txBox="1"/>
          <p:nvPr/>
        </p:nvSpPr>
        <p:spPr>
          <a:xfrm>
            <a:off x="3190294" y="3671899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2: Artefac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810AABE-B34B-40AB-8EEB-5C9776C9BF43}"/>
              </a:ext>
            </a:extLst>
          </p:cNvPr>
          <p:cNvSpPr txBox="1"/>
          <p:nvPr/>
        </p:nvSpPr>
        <p:spPr>
          <a:xfrm>
            <a:off x="8817376" y="3674724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4: Artefact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0CCB8F1-214B-7C07-1726-AFF6A902409E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AF8B387-453E-AF3D-9FAE-5409077311D4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8762475-F033-F6C2-B373-0446F79166A9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7A50280-0EFB-3583-7E82-ECB750AD7BF5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FE61FC5A-BE50-AC5F-0415-1D7F07231186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/>
              <a:t>Figure S1F</a:t>
            </a:r>
          </a:p>
        </p:txBody>
      </p:sp>
    </p:spTree>
    <p:extLst>
      <p:ext uri="{BB962C8B-B14F-4D97-AF65-F5344CB8AC3E}">
        <p14:creationId xmlns:p14="http://schemas.microsoft.com/office/powerpoint/2010/main" val="3767655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64B15744-8174-211C-F3F9-AB750EA3E9BD}"/>
              </a:ext>
            </a:extLst>
          </p:cNvPr>
          <p:cNvSpPr/>
          <p:nvPr/>
        </p:nvSpPr>
        <p:spPr>
          <a:xfrm>
            <a:off x="475487" y="748717"/>
            <a:ext cx="3052093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324CDA-DBA4-CAD8-6E24-532B75F643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761" y="749808"/>
            <a:ext cx="2624328" cy="2889206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A99EA39D-B6F4-3E78-67E8-13CA78E834B4}"/>
              </a:ext>
            </a:extLst>
          </p:cNvPr>
          <p:cNvSpPr/>
          <p:nvPr/>
        </p:nvSpPr>
        <p:spPr>
          <a:xfrm>
            <a:off x="477456" y="1592285"/>
            <a:ext cx="2624328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6F9F113-ED47-C181-B836-A7FB280E8A61}"/>
              </a:ext>
            </a:extLst>
          </p:cNvPr>
          <p:cNvSpPr/>
          <p:nvPr/>
        </p:nvSpPr>
        <p:spPr>
          <a:xfrm>
            <a:off x="475487" y="2609052"/>
            <a:ext cx="2626297" cy="184067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B8D4E24-C2D7-B685-2F95-76AE0CE91524}"/>
              </a:ext>
            </a:extLst>
          </p:cNvPr>
          <p:cNvSpPr/>
          <p:nvPr/>
        </p:nvSpPr>
        <p:spPr>
          <a:xfrm>
            <a:off x="3042756" y="747518"/>
            <a:ext cx="249446" cy="289137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66A1973-8C36-8194-9FBB-3ABB74E9723A}"/>
              </a:ext>
            </a:extLst>
          </p:cNvPr>
          <p:cNvGrpSpPr/>
          <p:nvPr/>
        </p:nvGrpSpPr>
        <p:grpSpPr>
          <a:xfrm>
            <a:off x="3099815" y="693755"/>
            <a:ext cx="437113" cy="2980969"/>
            <a:chOff x="11453309" y="693755"/>
            <a:chExt cx="437113" cy="298096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ADB9475-3B0B-AD96-8411-71D25685852D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53309" y="2794697"/>
              <a:ext cx="80180" cy="75768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E219A18-24AE-FF2E-EBB0-889EDDD221AF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453309" y="1803960"/>
              <a:ext cx="80180" cy="75768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CAAE963-F31A-F38C-7725-08A865724CD5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453309" y="813223"/>
              <a:ext cx="80180" cy="75768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0C6C9D8-0EF5-4029-38F3-289044DB7CB0}"/>
                </a:ext>
              </a:extLst>
            </p:cNvPr>
            <p:cNvSpPr txBox="1"/>
            <p:nvPr/>
          </p:nvSpPr>
          <p:spPr>
            <a:xfrm>
              <a:off x="11454182" y="693755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67BFF59-BC75-7F9F-A3BD-09A66FE8D1F2}"/>
                </a:ext>
              </a:extLst>
            </p:cNvPr>
            <p:cNvSpPr txBox="1"/>
            <p:nvPr/>
          </p:nvSpPr>
          <p:spPr>
            <a:xfrm>
              <a:off x="11469136" y="1049921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FBDB94F-85A5-1DB5-D5A8-95907E18E3EC}"/>
                </a:ext>
              </a:extLst>
            </p:cNvPr>
            <p:cNvSpPr txBox="1"/>
            <p:nvPr/>
          </p:nvSpPr>
          <p:spPr>
            <a:xfrm>
              <a:off x="11466736" y="1444014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054BE8B-6495-BE4E-F20C-F9393295E0C0}"/>
                </a:ext>
              </a:extLst>
            </p:cNvPr>
            <p:cNvSpPr txBox="1"/>
            <p:nvPr/>
          </p:nvSpPr>
          <p:spPr>
            <a:xfrm>
              <a:off x="11454182" y="168085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7D3D483-4CDA-D4F3-3014-5CD6F891A7B0}"/>
                </a:ext>
              </a:extLst>
            </p:cNvPr>
            <p:cNvSpPr txBox="1"/>
            <p:nvPr/>
          </p:nvSpPr>
          <p:spPr>
            <a:xfrm>
              <a:off x="11469136" y="2037016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z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E52D9DE-B07F-427F-20D7-80E1662A4453}"/>
                </a:ext>
              </a:extLst>
            </p:cNvPr>
            <p:cNvSpPr txBox="1"/>
            <p:nvPr/>
          </p:nvSpPr>
          <p:spPr>
            <a:xfrm>
              <a:off x="11466736" y="2431109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2.3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BEA76DF-483C-524F-25E0-9CE52F6EB88E}"/>
                </a:ext>
              </a:extLst>
            </p:cNvPr>
            <p:cNvSpPr txBox="1"/>
            <p:nvPr/>
          </p:nvSpPr>
          <p:spPr>
            <a:xfrm>
              <a:off x="11462370" y="2678244"/>
              <a:ext cx="418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1e-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A635286-D819-8AE4-87E5-E3DDC0217DDF}"/>
                </a:ext>
              </a:extLst>
            </p:cNvPr>
            <p:cNvSpPr txBox="1"/>
            <p:nvPr/>
          </p:nvSpPr>
          <p:spPr>
            <a:xfrm>
              <a:off x="11477324" y="303441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p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5EF8B0D-7941-29A4-8A21-21EACFF03538}"/>
                </a:ext>
              </a:extLst>
            </p:cNvPr>
            <p:cNvSpPr txBox="1"/>
            <p:nvPr/>
          </p:nvSpPr>
          <p:spPr>
            <a:xfrm>
              <a:off x="11474924" y="3428503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chemeClr val="bg1"/>
                  </a:solidFill>
                </a:rPr>
                <a:t>0.05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F6B8C76D-99E2-E0A8-CCE4-0C6545EAEA4E}"/>
              </a:ext>
            </a:extLst>
          </p:cNvPr>
          <p:cNvSpPr txBox="1"/>
          <p:nvPr/>
        </p:nvSpPr>
        <p:spPr>
          <a:xfrm>
            <a:off x="702514" y="3766597"/>
            <a:ext cx="2651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IC25: Artefact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606D848-5FC3-87A6-F369-146B9DA7B9C4}"/>
              </a:ext>
            </a:extLst>
          </p:cNvPr>
          <p:cNvGrpSpPr/>
          <p:nvPr/>
        </p:nvGrpSpPr>
        <p:grpSpPr>
          <a:xfrm>
            <a:off x="82580" y="864079"/>
            <a:ext cx="410242" cy="2712758"/>
            <a:chOff x="82580" y="864079"/>
            <a:chExt cx="410242" cy="2712758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EB841EA-A237-6D4D-2C5F-8A6FAF267D90}"/>
                </a:ext>
              </a:extLst>
            </p:cNvPr>
            <p:cNvSpPr txBox="1"/>
            <p:nvPr/>
          </p:nvSpPr>
          <p:spPr>
            <a:xfrm rot="-5400000">
              <a:off x="-100129" y="1056920"/>
              <a:ext cx="78579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Initial</a:t>
              </a:r>
            </a:p>
            <a:p>
              <a:pPr algn="ctr"/>
              <a:r>
                <a:rPr lang="en-US" sz="1000"/>
                <a:t>componen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95C1D84-56E9-654B-D3DC-71267212D49F}"/>
                </a:ext>
              </a:extLst>
            </p:cNvPr>
            <p:cNvSpPr txBox="1"/>
            <p:nvPr/>
          </p:nvSpPr>
          <p:spPr>
            <a:xfrm rot="-5400000">
              <a:off x="-111865" y="2982283"/>
              <a:ext cx="7889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Z increase</a:t>
              </a:r>
            </a:p>
            <a:p>
              <a:pPr algn="ctr"/>
              <a:r>
                <a:rPr lang="en-US" sz="1000"/>
                <a:t>significanc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6166495-646A-0E4B-4117-18A51E26681E}"/>
                </a:ext>
              </a:extLst>
            </p:cNvPr>
            <p:cNvSpPr txBox="1"/>
            <p:nvPr/>
          </p:nvSpPr>
          <p:spPr>
            <a:xfrm rot="-5400000">
              <a:off x="-57958" y="2027196"/>
              <a:ext cx="68961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err="1"/>
                <a:t>Rapidtide</a:t>
              </a:r>
              <a:endParaRPr lang="en-US" sz="1000"/>
            </a:p>
            <a:p>
              <a:pPr algn="ctr"/>
              <a:r>
                <a:rPr lang="en-US" sz="1000"/>
                <a:t>corrected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3762A0D2-A51D-CDCC-C6DE-58421032696A}"/>
              </a:ext>
            </a:extLst>
          </p:cNvPr>
          <p:cNvSpPr txBox="1"/>
          <p:nvPr/>
        </p:nvSpPr>
        <p:spPr>
          <a:xfrm>
            <a:off x="566057" y="5826034"/>
            <a:ext cx="15293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1G</a:t>
            </a:r>
          </a:p>
        </p:txBody>
      </p:sp>
    </p:spTree>
    <p:extLst>
      <p:ext uri="{BB962C8B-B14F-4D97-AF65-F5344CB8AC3E}">
        <p14:creationId xmlns:p14="http://schemas.microsoft.com/office/powerpoint/2010/main" val="8095197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83CA1-2F3B-EEBA-10BF-926F80528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74070" y="136634"/>
            <a:ext cx="5043860" cy="617292"/>
          </a:xfrm>
        </p:spPr>
        <p:txBody>
          <a:bodyPr>
            <a:normAutofit/>
          </a:bodyPr>
          <a:lstStyle/>
          <a:p>
            <a:pPr marL="4763" algn="just"/>
            <a:r>
              <a:rPr lang="en-US" sz="1400" b="1" dirty="0">
                <a:latin typeface="+mn-lt"/>
              </a:rPr>
              <a:t>Table S1. </a:t>
            </a:r>
            <a:r>
              <a:rPr lang="en-US" sz="1400" dirty="0">
                <a:latin typeface="+mn-lt"/>
              </a:rPr>
              <a:t>Percentage of significantly changed brain voxels in each IC after Rapidtide denoising</a:t>
            </a:r>
          </a:p>
        </p:txBody>
      </p:sp>
      <p:graphicFrame>
        <p:nvGraphicFramePr>
          <p:cNvPr id="4" name="Table 26">
            <a:extLst>
              <a:ext uri="{FF2B5EF4-FFF2-40B4-BE49-F238E27FC236}">
                <a16:creationId xmlns:a16="http://schemas.microsoft.com/office/drawing/2014/main" id="{401CB0F7-CAA2-DAEC-AEF9-945BA3A7F0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3870507"/>
              </p:ext>
            </p:extLst>
          </p:nvPr>
        </p:nvGraphicFramePr>
        <p:xfrm>
          <a:off x="3574070" y="727636"/>
          <a:ext cx="5043860" cy="5817248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1260965">
                  <a:extLst>
                    <a:ext uri="{9D8B030D-6E8A-4147-A177-3AD203B41FA5}">
                      <a16:colId xmlns:a16="http://schemas.microsoft.com/office/drawing/2014/main" val="592568586"/>
                    </a:ext>
                  </a:extLst>
                </a:gridCol>
                <a:gridCol w="1260965">
                  <a:extLst>
                    <a:ext uri="{9D8B030D-6E8A-4147-A177-3AD203B41FA5}">
                      <a16:colId xmlns:a16="http://schemas.microsoft.com/office/drawing/2014/main" val="3661118344"/>
                    </a:ext>
                  </a:extLst>
                </a:gridCol>
                <a:gridCol w="1260965">
                  <a:extLst>
                    <a:ext uri="{9D8B030D-6E8A-4147-A177-3AD203B41FA5}">
                      <a16:colId xmlns:a16="http://schemas.microsoft.com/office/drawing/2014/main" val="460678997"/>
                    </a:ext>
                  </a:extLst>
                </a:gridCol>
                <a:gridCol w="1260965">
                  <a:extLst>
                    <a:ext uri="{9D8B030D-6E8A-4147-A177-3AD203B41FA5}">
                      <a16:colId xmlns:a16="http://schemas.microsoft.com/office/drawing/2014/main" val="674354402"/>
                    </a:ext>
                  </a:extLst>
                </a:gridCol>
              </a:tblGrid>
              <a:tr h="6018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I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Number of significantly changed voxel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otal number of voxels in bra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ercentage of voxels change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82887650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894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9.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8758613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497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8.6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04688551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0334505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497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7.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56756584"/>
                  </a:ext>
                </a:extLst>
              </a:tr>
              <a:tr h="2193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4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904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9.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0884453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6206087"/>
                  </a:ext>
                </a:extLst>
              </a:tr>
              <a:tr h="2242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6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9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0.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11517134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7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8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2.9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63857667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8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79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4.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4729962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9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36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3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05367919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36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2.9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8638882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67555211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72913872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8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.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43556817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4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9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0.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1091904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99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5.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57046961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6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16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8.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38460308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7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4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7.6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41754477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8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71277073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9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99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2.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54695420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0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43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5.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59292406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4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9.6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34610276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534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8.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107039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204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9.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56696304"/>
                  </a:ext>
                </a:extLst>
              </a:tr>
              <a:tr h="207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4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70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3.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903832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6885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6</TotalTime>
  <Words>528</Words>
  <Application>Microsoft Macintosh PowerPoint</Application>
  <PresentationFormat>Widescreen</PresentationFormat>
  <Paragraphs>24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Supplementary materials – network comparison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S1. Percentage of significantly changed brain voxels in each IC after Rapidtide denoising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erick, Blaise B.</dc:creator>
  <cp:lastModifiedBy>Kohut, Stephen John,Ph.D.</cp:lastModifiedBy>
  <cp:revision>23</cp:revision>
  <dcterms:created xsi:type="dcterms:W3CDTF">2022-08-17T15:44:55Z</dcterms:created>
  <dcterms:modified xsi:type="dcterms:W3CDTF">2022-11-30T17:42:50Z</dcterms:modified>
</cp:coreProperties>
</file>